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5">
  <p:sldMasterIdLst>
    <p:sldMasterId id="2147483648" r:id="rId4"/>
  </p:sldMasterIdLst>
  <p:notesMasterIdLst>
    <p:notesMasterId r:id="rId6"/>
  </p:notesMasterIdLst>
  <p:sldIdLst>
    <p:sldId id="29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31C418-18D7-FC01-4DB0-DB8C5F15C850}" name="Aziana Abu Hassan" initials="AAH" userId="Aziana Abu Hassan" providerId="None"/>
  <p188:author id="{307D5664-BCA0-BEA9-4FF5-496CF704CFAE}" name="Marko Hanzevacki (staff)" initials="MH(" userId="Marko Hanzevacki (staff)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E1EFA"/>
    <a:srgbClr val="FFA000"/>
    <a:srgbClr val="02FF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65" autoAdjust="0"/>
    <p:restoredTop sz="85830" autoAdjust="0"/>
  </p:normalViewPr>
  <p:slideViewPr>
    <p:cSldViewPr snapToGrid="0">
      <p:cViewPr varScale="1">
        <p:scale>
          <a:sx n="96" d="100"/>
          <a:sy n="96" d="100"/>
        </p:scale>
        <p:origin x="11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ca Pordea (staff)" userId="04217c9e-4602-4538-8d25-5638668eb9f5" providerId="ADAL" clId="{BCA4C0EA-C5AA-4AE4-96E9-00BF5FD47AEF}"/>
    <pc:docChg chg="delSld modSld">
      <pc:chgData name="Anca Pordea (staff)" userId="04217c9e-4602-4538-8d25-5638668eb9f5" providerId="ADAL" clId="{BCA4C0EA-C5AA-4AE4-96E9-00BF5FD47AEF}" dt="2023-12-19T19:14:56.145" v="19" actId="1038"/>
      <pc:docMkLst>
        <pc:docMk/>
      </pc:docMkLst>
      <pc:sldChg chg="del">
        <pc:chgData name="Anca Pordea (staff)" userId="04217c9e-4602-4538-8d25-5638668eb9f5" providerId="ADAL" clId="{BCA4C0EA-C5AA-4AE4-96E9-00BF5FD47AEF}" dt="2023-12-18T19:19:28.338" v="0" actId="47"/>
        <pc:sldMkLst>
          <pc:docMk/>
          <pc:sldMk cId="1702511720" sldId="298"/>
        </pc:sldMkLst>
      </pc:sldChg>
      <pc:sldChg chg="addSp modSp mod">
        <pc:chgData name="Anca Pordea (staff)" userId="04217c9e-4602-4538-8d25-5638668eb9f5" providerId="ADAL" clId="{BCA4C0EA-C5AA-4AE4-96E9-00BF5FD47AEF}" dt="2023-12-19T19:14:56.145" v="19" actId="1038"/>
        <pc:sldMkLst>
          <pc:docMk/>
          <pc:sldMk cId="4077862176" sldId="299"/>
        </pc:sldMkLst>
        <pc:spChg chg="add mod">
          <ac:chgData name="Anca Pordea (staff)" userId="04217c9e-4602-4538-8d25-5638668eb9f5" providerId="ADAL" clId="{BCA4C0EA-C5AA-4AE4-96E9-00BF5FD47AEF}" dt="2023-12-19T19:14:46.012" v="5" actId="1076"/>
          <ac:spMkLst>
            <pc:docMk/>
            <pc:sldMk cId="4077862176" sldId="299"/>
            <ac:spMk id="4" creationId="{288CAC71-1EAB-793A-78A9-5BD32B208DC3}"/>
          </ac:spMkLst>
        </pc:spChg>
        <pc:graphicFrameChg chg="mod modGraphic">
          <ac:chgData name="Anca Pordea (staff)" userId="04217c9e-4602-4538-8d25-5638668eb9f5" providerId="ADAL" clId="{BCA4C0EA-C5AA-4AE4-96E9-00BF5FD47AEF}" dt="2023-12-19T19:14:56.145" v="19" actId="1038"/>
          <ac:graphicFrameMkLst>
            <pc:docMk/>
            <pc:sldMk cId="4077862176" sldId="299"/>
            <ac:graphicFrameMk id="3" creationId="{2B960076-4ED0-D55E-C50E-8B5FCB747444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86DAC8-0F5C-40C4-9048-03E5F0338584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2B562-5671-4D39-9920-23E3852B6F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840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5 Tabl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st of residues interacting with the docked </a:t>
            </a:r>
            <a:r>
              <a:rPr lang="en-GB" sz="18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s-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4-polyisoprene, extracted from PLIP analysis of 10 docking poses obtained using </a:t>
            </a:r>
            <a:r>
              <a:rPr lang="en-GB" sz="18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mScore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Docking solutions were ranked based on the fitness score from highest to lowest. Residues that interact with all / most poses are highlighted in grey and light grey, respectively.</a:t>
            </a:r>
            <a:endParaRPr lang="en-MY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2B562-5671-4D39-9920-23E3852B6FD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31694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839CC-2F4F-9676-481C-A8C6BD60D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B78B30-6C9E-9383-5A22-347469CEE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F3B91-4E34-CF19-361A-C8592EC86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C2D85-0EFD-F1E1-E255-D409A42D7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4A4AE-7753-7C00-721D-98EB26BA0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39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454C2-05D2-40B2-C98F-42188163E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A9FF01-EC14-452C-3CE0-F69E79070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E166A-724F-0654-6132-EB6D136E6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865FF-D369-A9FB-BE86-F396D4D2E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AD3664-4433-2CAF-0724-6D43A5EDC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828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E88ECF-540D-9D8B-AA3D-0BFBCF95FB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F5B47-A83B-3433-E305-0968F562A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4D5D9-63A2-6610-C517-62DD48C0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9AA1-97FE-DF9C-A3CB-5C208B826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5377F-1DCC-3F4C-1493-4EB469A4B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1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743F2-CAC8-CCE5-22CC-8CCBCD2DF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F9F779-89A1-544A-951D-A892F041EA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9A8DE-F0E3-F7D3-F0D4-FF0540892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D0439-C25F-AD3D-FB4B-F9C044F03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2FB56-DEEF-B1EC-BB2B-6B06B28E5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12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D81C7-B648-ECBB-EB5A-190AA8780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8D037-CFF8-3CAE-B59F-42FF4DE91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3928D-3201-D840-2A36-11982338F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EDBB0-1CBA-B1A9-36C6-CD364295E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EA93A-115B-D044-5063-CCA7ACB1C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324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D1655-2CC5-8A36-679E-B66A3C818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E9BB75-23E1-8048-21F0-8291ADA465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1A3F4A-1C5D-7B02-8B21-9555A3572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E35E8-F04A-5333-D410-00E24329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A075AA-CC28-DF86-0F94-4D99C3AC9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BFF910-1687-8D7A-1E60-FB4E3700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94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6B51B-A49C-DB81-129D-770B7B81E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D9DB3-E956-030A-1DF5-3FB9D03B44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D2E3A9-FCD4-5AFE-85C4-F8F4DDA71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A0BCEB-5EF9-7EE9-599C-6B94A4674A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92368-689C-6BF0-C77F-0FC8D9730B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21DC13-1D6B-88D7-E33B-841299F68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1249E9-F2D9-4CE8-E6E4-69784C915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DCCF0F-0559-9B9A-9D3B-F937169A2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448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E970B-DA53-0A74-ECA7-73762CEB3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14DDAA-CD12-6445-0D2D-6426A9B8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4ED273-A5E0-4AA0-9FB8-376853020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4533B-EB08-5EF6-12E6-A61B91BB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04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CCA8A7-6C30-3E41-FDA4-305B64DA9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98FDF7-8B82-C3B9-B1D3-F8A0D4019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B7E57B-3FA1-1E79-D470-B0A644558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2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032A7-73AA-3738-F12D-A9F0F15F7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9093D-A355-AE1D-2978-2A6700274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E4AE4-E591-8AD3-0D49-79DAC0AD2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C028F-B9A0-811D-83B5-8780FC264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1EC2C9-44C6-5DDA-05D2-3CBF197BF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A6038-8120-45EA-B5FE-EDC53B703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556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EFBDF-8326-737F-3DE1-8A0F176EF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5A8341-5D99-22B5-5588-0F213643C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1F0F35-0A56-8640-3CB0-13C12B476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94D0A3-D271-0D2E-F074-B7ACC0632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72C26D-735A-EDE8-811B-C6F37C007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E86F7-F0E0-0A6F-02B3-303AB6C43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66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F7FA97-498A-322A-7FC1-14CEFA006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761D6-4CC6-BD9F-31FF-4C66405D9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92A81E-83E9-C733-B6FA-CCC1763CC7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18AAE-C4F2-C908-CFD8-36D483C0CB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62CB5-FAC8-96AE-9FC4-FD1DF197A0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404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B960076-4ED0-D55E-C50E-8B5FCB7474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8930366"/>
              </p:ext>
            </p:extLst>
          </p:nvPr>
        </p:nvGraphicFramePr>
        <p:xfrm>
          <a:off x="2803969" y="856374"/>
          <a:ext cx="5647634" cy="5880319"/>
        </p:xfrm>
        <a:graphic>
          <a:graphicData uri="http://schemas.openxmlformats.org/drawingml/2006/table">
            <a:tbl>
              <a:tblPr firstRow="1" firstCol="1" bandRow="1"/>
              <a:tblGrid>
                <a:gridCol w="1086934">
                  <a:extLst>
                    <a:ext uri="{9D8B030D-6E8A-4147-A177-3AD203B41FA5}">
                      <a16:colId xmlns:a16="http://schemas.microsoft.com/office/drawing/2014/main" val="1616926198"/>
                    </a:ext>
                  </a:extLst>
                </a:gridCol>
                <a:gridCol w="1323740">
                  <a:extLst>
                    <a:ext uri="{9D8B030D-6E8A-4147-A177-3AD203B41FA5}">
                      <a16:colId xmlns:a16="http://schemas.microsoft.com/office/drawing/2014/main" val="2208666333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789719891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3195272779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3543680407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1976719108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2975234819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3805887771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1878033814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2981118056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2681603419"/>
                    </a:ext>
                  </a:extLst>
                </a:gridCol>
                <a:gridCol w="323696">
                  <a:extLst>
                    <a:ext uri="{9D8B030D-6E8A-4147-A177-3AD203B41FA5}">
                      <a16:colId xmlns:a16="http://schemas.microsoft.com/office/drawing/2014/main" val="282241818"/>
                    </a:ext>
                  </a:extLst>
                </a:gridCol>
              </a:tblGrid>
              <a:tr h="155485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esidue number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of poses interacting with residue 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0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ose rank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7092705"/>
                  </a:ext>
                </a:extLst>
              </a:tr>
              <a:tr h="409457">
                <a:tc v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3894614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S8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2842394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14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3973354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LU14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0445311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15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3143400"/>
                  </a:ext>
                </a:extLst>
              </a:tr>
              <a:tr h="15548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A159 </a:t>
                      </a:r>
                      <a:endParaRPr lang="en-MY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0033446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P16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6232563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RG16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565006"/>
                  </a:ext>
                </a:extLst>
              </a:tr>
              <a:tr h="15548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S16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3702958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16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3563385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RG17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339718"/>
                  </a:ext>
                </a:extLst>
              </a:tr>
              <a:tr h="15548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U17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88620468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YR17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2064350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P17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128235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17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3270932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189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2740766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19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6396937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S19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5261191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19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6021579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19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2605021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22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0830566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229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3043537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23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691899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P23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3590146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U23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101520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P26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6109879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A26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9337332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U26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7972063"/>
                  </a:ext>
                </a:extLst>
              </a:tr>
              <a:tr h="15548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396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5004139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A39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5587208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39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3181508"/>
                  </a:ext>
                </a:extLst>
              </a:tr>
              <a:tr h="17383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P399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0826" marR="4082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787019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88CAC71-1EAB-793A-78A9-5BD32B208DC3}"/>
              </a:ext>
            </a:extLst>
          </p:cNvPr>
          <p:cNvSpPr txBox="1"/>
          <p:nvPr/>
        </p:nvSpPr>
        <p:spPr>
          <a:xfrm>
            <a:off x="2625067" y="86933"/>
            <a:ext cx="609765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5 Table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st of residues interacting with the docked </a:t>
            </a:r>
            <a:r>
              <a:rPr lang="en-GB" sz="11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s-</a:t>
            </a: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4-polyisoprene, extracted from PLIP analysis of 10 docking poses obtained using </a:t>
            </a:r>
            <a:r>
              <a:rPr lang="en-GB" sz="11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mScore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Docking solutions were ranked based on the fitness score from highest to lowest. Residues that interact with all / most poses are highlighted in grey and light grey, respectively.</a:t>
            </a:r>
            <a:endParaRPr lang="en-MY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7862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c1e910d-4918-42f1-af2c-ed1101d63abc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17" ma:contentTypeDescription="Create a new document." ma:contentTypeScope="" ma:versionID="75a924c6fce2bfbfdafe8aa5030a8127">
  <xsd:schema xmlns:xsd="http://www.w3.org/2001/XMLSchema" xmlns:xs="http://www.w3.org/2001/XMLSchema" xmlns:p="http://schemas.microsoft.com/office/2006/metadata/properties" xmlns:ns3="0c1e910d-4918-42f1-af2c-ed1101d63abc" xmlns:ns4="786e620f-b1da-4f59-878c-ef7546d25bf1" targetNamespace="http://schemas.microsoft.com/office/2006/metadata/properties" ma:root="true" ma:fieldsID="84345ca33903240b6bb317a7195b494d" ns3:_="" ns4:_="">
    <xsd:import namespace="0c1e910d-4918-42f1-af2c-ed1101d63abc"/>
    <xsd:import namespace="786e620f-b1da-4f59-878c-ef7546d25bf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6e620f-b1da-4f59-878c-ef7546d25bf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555A585-BC5A-4ACF-8F83-4E3A66BDD946}">
  <ds:schemaRefs>
    <ds:schemaRef ds:uri="http://schemas.microsoft.com/office/2006/metadata/properties"/>
    <ds:schemaRef ds:uri="http://schemas.microsoft.com/office/infopath/2007/PartnerControls"/>
    <ds:schemaRef ds:uri="http://schemas.microsoft.com/office/2006/documentManagement/types"/>
    <ds:schemaRef ds:uri="http://schemas.openxmlformats.org/package/2006/metadata/core-properties"/>
    <ds:schemaRef ds:uri="786e620f-b1da-4f59-878c-ef7546d25bf1"/>
    <ds:schemaRef ds:uri="http://purl.org/dc/dcmitype/"/>
    <ds:schemaRef ds:uri="0c1e910d-4918-42f1-af2c-ed1101d63abc"/>
    <ds:schemaRef ds:uri="http://www.w3.org/XML/1998/namespace"/>
    <ds:schemaRef ds:uri="http://purl.org/dc/terms/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95A7B98B-2C55-48C5-B622-1549557E3C5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c1e910d-4918-42f1-af2c-ed1101d63abc"/>
    <ds:schemaRef ds:uri="786e620f-b1da-4f59-878c-ef7546d25b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8BC3993-CD11-46D5-AFD3-539F9D1D026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414</TotalTime>
  <Words>312</Words>
  <Application>Microsoft Office PowerPoint</Application>
  <PresentationFormat>Widescreen</PresentationFormat>
  <Paragraphs>19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o Hanzevacki (staff)</dc:creator>
  <cp:lastModifiedBy>Anca Pordea (staff)</cp:lastModifiedBy>
  <cp:revision>366</cp:revision>
  <dcterms:created xsi:type="dcterms:W3CDTF">2022-09-23T18:06:25Z</dcterms:created>
  <dcterms:modified xsi:type="dcterms:W3CDTF">2023-12-19T19:15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